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9" r:id="rId3"/>
  </p:sldIdLst>
  <p:sldSz cx="6858000" cy="9906000" type="A4"/>
  <p:notesSz cx="6858000" cy="9144000"/>
  <p:custDataLst>
    <p:tags r:id="rId7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304" autoAdjust="0"/>
    <p:restoredTop sz="94660"/>
  </p:normalViewPr>
  <p:slideViewPr>
    <p:cSldViewPr snapToGrid="0" showGuides="1">
      <p:cViewPr varScale="1">
        <p:scale>
          <a:sx n="75" d="100"/>
          <a:sy n="75" d="100"/>
        </p:scale>
        <p:origin x="1608" y="6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1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 hasCustomPrompt="1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 hasCustomPrompt="1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7.xml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图片 12" descr="human_cnv_Ysignal_adjust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591927" y="3259224"/>
            <a:ext cx="2128520" cy="2128520"/>
          </a:xfrm>
          <a:prstGeom prst="rect">
            <a:avLst/>
          </a:prstGeom>
        </p:spPr>
      </p:pic>
      <p:pic>
        <p:nvPicPr>
          <p:cNvPr id="3" name="图片 2" descr="human_cnv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9200" y="3179214"/>
            <a:ext cx="2209800" cy="220980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094908" y="367152"/>
            <a:ext cx="265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0" y="5704470"/>
            <a:ext cx="6857999" cy="181588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just"/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de-DE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2. Y </a:t>
            </a:r>
            <a:r>
              <a:rPr lang="de-DE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hromosome-related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GSVA </a:t>
            </a:r>
            <a:r>
              <a:rPr lang="de-DE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re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nd genomic Y chromosome signal in several patient cohorts.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ot plots illustrat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the GSVA scores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based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on Y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chromosome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genes for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females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males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two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datasets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SE227919 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A) and 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SE26549 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(C) 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ot plots shows the Y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hromosome 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ignal and adjusted Y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chromosome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signal for progressor and non-progressor samples from male samples in the 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msterdam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UMC cohort. 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(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D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) Dot plot shows the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adjusted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Y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chromosome</a:t>
            </a:r>
            <a:r>
              <a:rPr lang="en-US" altLang="de-DE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signal for 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OPMD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samples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with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or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without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progress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ion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into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OSCC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for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males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of 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the 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Amsterdam 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UMC cohort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 descr="GSE227919_dotplot_gender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87780" y="694677"/>
            <a:ext cx="2141220" cy="2141220"/>
          </a:xfrm>
          <a:prstGeom prst="rect">
            <a:avLst/>
          </a:prstGeom>
        </p:spPr>
      </p:pic>
      <p:pic>
        <p:nvPicPr>
          <p:cNvPr id="10" name="图片 9" descr="GSE26549_dotplot_gender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08742" y="657847"/>
            <a:ext cx="2178050" cy="2178050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1094908" y="2914527"/>
            <a:ext cx="222885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C</a:t>
            </a:r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3326933" y="2914527"/>
            <a:ext cx="238125" cy="36957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D</a:t>
            </a:r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12" name="文本框 14"/>
          <p:cNvSpPr txBox="1"/>
          <p:nvPr/>
        </p:nvSpPr>
        <p:spPr>
          <a:xfrm>
            <a:off x="3326933" y="367152"/>
            <a:ext cx="238125" cy="36957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algn="ctr"/>
            <a:r>
              <a:rPr lang="de-DE" altLang="zh-CN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B</a:t>
            </a:r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ZGQ2OGFkOTMxOTRjMjAwNGJjNzU4YzIzNGY2NWUwNzUifQ=="/>
</p:tagLst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67</Words>
  <Application>WPS 演示</Application>
  <PresentationFormat>A4-Papier (210 x 297 mm)</PresentationFormat>
  <Paragraphs>1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Arial</vt:lpstr>
      <vt:lpstr>宋体</vt:lpstr>
      <vt:lpstr>Wingdings</vt:lpstr>
      <vt:lpstr>微软雅黑</vt:lpstr>
      <vt:lpstr>Arial Unicode MS</vt:lpstr>
      <vt:lpstr>Offic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eß, Jochen</dc:creator>
  <cp:lastModifiedBy>韩蕊</cp:lastModifiedBy>
  <cp:revision>37</cp:revision>
  <dcterms:created xsi:type="dcterms:W3CDTF">2024-09-10T14:28:00Z</dcterms:created>
  <dcterms:modified xsi:type="dcterms:W3CDTF">2025-07-21T02:02:5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D6E60A1633A442EAA0CE53EB4377AEE4_13</vt:lpwstr>
  </property>
  <property fmtid="{D5CDD505-2E9C-101B-9397-08002B2CF9AE}" pid="3" name="KSOProductBuildVer">
    <vt:lpwstr>2052-12.1.0.21915</vt:lpwstr>
  </property>
</Properties>
</file>